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5" d="100"/>
          <a:sy n="75" d="100"/>
        </p:scale>
        <p:origin x="-1056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CEBEE-D6EF-4780-8ED6-A7AB43A10ABB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43BD4D-1119-4082-85F2-CA37254033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716652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CEBEE-D6EF-4780-8ED6-A7AB43A10ABB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43BD4D-1119-4082-85F2-CA37254033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800179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CEBEE-D6EF-4780-8ED6-A7AB43A10ABB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43BD4D-1119-4082-85F2-CA37254033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44176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CEBEE-D6EF-4780-8ED6-A7AB43A10ABB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43BD4D-1119-4082-85F2-CA37254033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37232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CEBEE-D6EF-4780-8ED6-A7AB43A10ABB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43BD4D-1119-4082-85F2-CA37254033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58007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CEBEE-D6EF-4780-8ED6-A7AB43A10ABB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43BD4D-1119-4082-85F2-CA37254033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505331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CEBEE-D6EF-4780-8ED6-A7AB43A10ABB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43BD4D-1119-4082-85F2-CA37254033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681060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CEBEE-D6EF-4780-8ED6-A7AB43A10ABB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43BD4D-1119-4082-85F2-CA37254033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725147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CEBEE-D6EF-4780-8ED6-A7AB43A10ABB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43BD4D-1119-4082-85F2-CA37254033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82017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CEBEE-D6EF-4780-8ED6-A7AB43A10ABB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43BD4D-1119-4082-85F2-CA37254033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71655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CEBEE-D6EF-4780-8ED6-A7AB43A10ABB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43BD4D-1119-4082-85F2-CA37254033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755544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FCEBEE-D6EF-4780-8ED6-A7AB43A10ABB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43BD4D-1119-4082-85F2-CA37254033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60959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611560" y="404664"/>
            <a:ext cx="835292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/>
              <a:t>Figure S8 Amino acid sequence alignment of melon </a:t>
            </a:r>
            <a:r>
              <a:rPr lang="en-US" altLang="zh-CN" b="1" i="1" dirty="0"/>
              <a:t>CmADH9</a:t>
            </a:r>
            <a:r>
              <a:rPr lang="en-US" altLang="zh-CN" b="1" dirty="0"/>
              <a:t> (MELO3C011043 P1) with closely related sequences of other plants. </a:t>
            </a:r>
            <a:endParaRPr lang="zh-CN" altLang="en-US" dirty="0"/>
          </a:p>
        </p:txBody>
      </p:sp>
      <p:sp>
        <p:nvSpPr>
          <p:cNvPr id="5" name="Rectangle 20"/>
          <p:cNvSpPr>
            <a:spLocks noChangeArrowheads="1"/>
          </p:cNvSpPr>
          <p:nvPr/>
        </p:nvSpPr>
        <p:spPr bwMode="auto">
          <a:xfrm>
            <a:off x="152400" y="15240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grpSp>
        <p:nvGrpSpPr>
          <p:cNvPr id="6" name="Group 1"/>
          <p:cNvGrpSpPr>
            <a:grpSpLocks/>
          </p:cNvGrpSpPr>
          <p:nvPr/>
        </p:nvGrpSpPr>
        <p:grpSpPr bwMode="auto">
          <a:xfrm>
            <a:off x="960136" y="1464250"/>
            <a:ext cx="6852223" cy="3692942"/>
            <a:chOff x="0" y="0"/>
            <a:chExt cx="11878" cy="5302"/>
          </a:xfrm>
        </p:grpSpPr>
        <p:sp>
          <p:nvSpPr>
            <p:cNvPr id="7" name="AutoShape 19"/>
            <p:cNvSpPr>
              <a:spLocks noChangeAspect="1" noChangeArrowheads="1" noTextEdit="1"/>
            </p:cNvSpPr>
            <p:nvPr/>
          </p:nvSpPr>
          <p:spPr bwMode="auto">
            <a:xfrm>
              <a:off x="0" y="0"/>
              <a:ext cx="11878" cy="530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pic>
          <p:nvPicPr>
            <p:cNvPr id="2066" name="Picture 18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0"/>
              <a:ext cx="11878" cy="235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</p:pic>
        <p:pic>
          <p:nvPicPr>
            <p:cNvPr id="2065" name="Picture 17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2469"/>
              <a:ext cx="11878" cy="235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</p:pic>
        <p:sp>
          <p:nvSpPr>
            <p:cNvPr id="8" name="Rectangle 16"/>
            <p:cNvSpPr>
              <a:spLocks noChangeArrowheads="1"/>
            </p:cNvSpPr>
            <p:nvPr/>
          </p:nvSpPr>
          <p:spPr bwMode="auto">
            <a:xfrm>
              <a:off x="1367" y="0"/>
              <a:ext cx="2048" cy="2372"/>
            </a:xfrm>
            <a:prstGeom prst="rect">
              <a:avLst/>
            </a:prstGeom>
            <a:noFill/>
            <a:ln w="28575">
              <a:solidFill>
                <a:srgbClr val="FF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" name="Rectangle 15"/>
            <p:cNvSpPr>
              <a:spLocks noChangeArrowheads="1"/>
            </p:cNvSpPr>
            <p:nvPr/>
          </p:nvSpPr>
          <p:spPr bwMode="auto">
            <a:xfrm>
              <a:off x="4003" y="0"/>
              <a:ext cx="3415" cy="2372"/>
            </a:xfrm>
            <a:prstGeom prst="rect">
              <a:avLst/>
            </a:prstGeom>
            <a:noFill/>
            <a:ln w="28575">
              <a:solidFill>
                <a:srgbClr val="FF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" name="Rectangle 14"/>
            <p:cNvSpPr>
              <a:spLocks noChangeArrowheads="1"/>
            </p:cNvSpPr>
            <p:nvPr/>
          </p:nvSpPr>
          <p:spPr bwMode="auto">
            <a:xfrm>
              <a:off x="9079" y="2469"/>
              <a:ext cx="878" cy="2372"/>
            </a:xfrm>
            <a:prstGeom prst="rect">
              <a:avLst/>
            </a:prstGeom>
            <a:noFill/>
            <a:ln w="28575">
              <a:solidFill>
                <a:srgbClr val="FF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1" name="Text Box 13"/>
            <p:cNvSpPr txBox="1">
              <a:spLocks noChangeArrowheads="1"/>
            </p:cNvSpPr>
            <p:nvPr/>
          </p:nvSpPr>
          <p:spPr bwMode="auto">
            <a:xfrm>
              <a:off x="8005" y="4840"/>
              <a:ext cx="3514" cy="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4864" tIns="27432" rIns="54864" bIns="27432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NADPH binding motif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2" name="Text Box 12"/>
            <p:cNvSpPr txBox="1">
              <a:spLocks noChangeArrowheads="1"/>
            </p:cNvSpPr>
            <p:nvPr/>
          </p:nvSpPr>
          <p:spPr bwMode="auto">
            <a:xfrm>
              <a:off x="977" y="2372"/>
              <a:ext cx="2684" cy="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4864" tIns="27432" rIns="54864" bIns="27432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Zn1 binding motif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3" name="Text Box 11"/>
            <p:cNvSpPr txBox="1">
              <a:spLocks noChangeArrowheads="1"/>
            </p:cNvSpPr>
            <p:nvPr/>
          </p:nvSpPr>
          <p:spPr bwMode="auto">
            <a:xfrm>
              <a:off x="4391" y="2372"/>
              <a:ext cx="3027" cy="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4864" tIns="27432" rIns="54864" bIns="27432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Zn2 binding motif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4" name="Rectangle 10"/>
            <p:cNvSpPr>
              <a:spLocks noChangeArrowheads="1"/>
            </p:cNvSpPr>
            <p:nvPr/>
          </p:nvSpPr>
          <p:spPr bwMode="auto">
            <a:xfrm>
              <a:off x="5270" y="0"/>
              <a:ext cx="389" cy="3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2793" tIns="21397" rIns="42793" bIns="21397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▼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5" name="Rectangle 9"/>
            <p:cNvSpPr>
              <a:spLocks noChangeArrowheads="1"/>
            </p:cNvSpPr>
            <p:nvPr/>
          </p:nvSpPr>
          <p:spPr bwMode="auto">
            <a:xfrm>
              <a:off x="5662" y="0"/>
              <a:ext cx="390" cy="3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2793" tIns="21397" rIns="42793" bIns="21397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▼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6" name="Rectangle 8"/>
            <p:cNvSpPr>
              <a:spLocks noChangeArrowheads="1"/>
            </p:cNvSpPr>
            <p:nvPr/>
          </p:nvSpPr>
          <p:spPr bwMode="auto">
            <a:xfrm>
              <a:off x="6052" y="0"/>
              <a:ext cx="389" cy="3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2793" tIns="21397" rIns="42793" bIns="21397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▼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7" name="Rectangle 7"/>
            <p:cNvSpPr>
              <a:spLocks noChangeArrowheads="1"/>
            </p:cNvSpPr>
            <p:nvPr/>
          </p:nvSpPr>
          <p:spPr bwMode="auto">
            <a:xfrm>
              <a:off x="7125" y="0"/>
              <a:ext cx="389" cy="3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2793" tIns="21397" rIns="42793" bIns="21397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▼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8" name="Rectangle 6"/>
            <p:cNvSpPr>
              <a:spLocks noChangeArrowheads="1"/>
            </p:cNvSpPr>
            <p:nvPr/>
          </p:nvSpPr>
          <p:spPr bwMode="auto">
            <a:xfrm>
              <a:off x="1368" y="0"/>
              <a:ext cx="455" cy="3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4864" tIns="27432" rIns="54864" bIns="27432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▽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9" name="Rectangle 5"/>
            <p:cNvSpPr>
              <a:spLocks noChangeArrowheads="1"/>
            </p:cNvSpPr>
            <p:nvPr/>
          </p:nvSpPr>
          <p:spPr bwMode="auto">
            <a:xfrm>
              <a:off x="1463" y="0"/>
              <a:ext cx="456" cy="3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4864" tIns="27432" rIns="54864" bIns="27432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▽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0" name="Rectangle 4"/>
            <p:cNvSpPr>
              <a:spLocks noChangeArrowheads="1"/>
            </p:cNvSpPr>
            <p:nvPr/>
          </p:nvSpPr>
          <p:spPr bwMode="auto">
            <a:xfrm>
              <a:off x="9079" y="2570"/>
              <a:ext cx="220" cy="3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1148" tIns="20574" rIns="41148" bIns="20574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●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1" name="Rectangle 3"/>
            <p:cNvSpPr>
              <a:spLocks noChangeArrowheads="1"/>
            </p:cNvSpPr>
            <p:nvPr/>
          </p:nvSpPr>
          <p:spPr bwMode="auto">
            <a:xfrm>
              <a:off x="9273" y="2570"/>
              <a:ext cx="219" cy="3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1148" tIns="20574" rIns="41148" bIns="20574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●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2" name="Rectangle 2"/>
            <p:cNvSpPr>
              <a:spLocks noChangeArrowheads="1"/>
            </p:cNvSpPr>
            <p:nvPr/>
          </p:nvSpPr>
          <p:spPr bwMode="auto">
            <a:xfrm>
              <a:off x="9762" y="2570"/>
              <a:ext cx="218" cy="3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1148" tIns="20574" rIns="41148" bIns="20574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●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</p:grpSp>
      <p:pic>
        <p:nvPicPr>
          <p:cNvPr id="25" name="Picture 5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72758" y="6021288"/>
            <a:ext cx="2425700" cy="5207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4687594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9</Words>
  <Application>Microsoft Office PowerPoint</Application>
  <PresentationFormat>全屏显示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Company>Lenov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C SYSTEM</dc:creator>
  <cp:lastModifiedBy>MC SYSTEM</cp:lastModifiedBy>
  <cp:revision>1</cp:revision>
  <dcterms:created xsi:type="dcterms:W3CDTF">2015-04-21T06:34:47Z</dcterms:created>
  <dcterms:modified xsi:type="dcterms:W3CDTF">2015-04-21T06:35:56Z</dcterms:modified>
</cp:coreProperties>
</file>